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8" d="100"/>
          <a:sy n="88" d="100"/>
        </p:scale>
        <p:origin x="-139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5346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2229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3971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0881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2136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10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5512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2649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5937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4493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5358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51BCF-81D9-884F-A1C3-997304B25B16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69D3D-70AC-9F4D-9778-89699D169A5F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2562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Macintosh HD:Users:Ruddy:Desktop:Figuras paper Vit D:Figure 2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0193" y="529227"/>
            <a:ext cx="4227624" cy="6628672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CuadroTexto 4"/>
          <p:cNvSpPr txBox="1"/>
          <p:nvPr/>
        </p:nvSpPr>
        <p:spPr>
          <a:xfrm>
            <a:off x="119531" y="7150911"/>
            <a:ext cx="663388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/>
              <a:t>Supplementary Figure 2: </a:t>
            </a:r>
            <a:r>
              <a:rPr lang="en-GB" sz="1400" b="1" dirty="0"/>
              <a:t>Comparison between vitamin D levels along the seasons within the groups (normal and insufficiency).</a:t>
            </a:r>
            <a:r>
              <a:rPr lang="en-GB" sz="1400" dirty="0"/>
              <a:t> In the insufficiency group the differences between summer and winter vitamin D levels are statistically significant. However, the normal group did not show any significant variation in vitamin D levels along the seasons. Data have been analysed with a non-parametric test (</a:t>
            </a:r>
            <a:r>
              <a:rPr lang="en-GB" sz="1400" dirty="0" err="1"/>
              <a:t>Kruskal</a:t>
            </a:r>
            <a:r>
              <a:rPr lang="en-GB" sz="1400" dirty="0"/>
              <a:t>-Wallis test) followed by a Dunns multiple comparison test. * p&lt;0.05</a:t>
            </a:r>
            <a:endParaRPr lang="es-ES" sz="1400" dirty="0"/>
          </a:p>
          <a:p>
            <a:pPr algn="just"/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23543097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5</Words>
  <Application>Microsoft Macintosh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NEIRID LAB  XXI SANTIAG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Oreste Gualillo</dc:creator>
  <cp:lastModifiedBy>Oreste Gualillo</cp:lastModifiedBy>
  <cp:revision>2</cp:revision>
  <dcterms:created xsi:type="dcterms:W3CDTF">2018-10-25T07:36:58Z</dcterms:created>
  <dcterms:modified xsi:type="dcterms:W3CDTF">2018-10-30T10:09:38Z</dcterms:modified>
</cp:coreProperties>
</file>